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  <p:sldId id="258" r:id="rId3"/>
    <p:sldId id="256" r:id="rId4"/>
    <p:sldId id="257" r:id="rId5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202" autoAdjust="0"/>
    <p:restoredTop sz="94660"/>
  </p:normalViewPr>
  <p:slideViewPr>
    <p:cSldViewPr snapToGrid="0">
      <p:cViewPr varScale="1">
        <p:scale>
          <a:sx n="150" d="100"/>
          <a:sy n="150" d="100"/>
        </p:scale>
        <p:origin x="4674" y="1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D121A3-E3E5-469B-98E6-DF38CE66B53F}" type="datetimeFigureOut">
              <a:rPr lang="zh-CN" altLang="en-US" smtClean="0"/>
              <a:t>2023/6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CDAF7-D72C-469C-A9C4-EE2B49156CC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862989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D121A3-E3E5-469B-98E6-DF38CE66B53F}" type="datetimeFigureOut">
              <a:rPr lang="zh-CN" altLang="en-US" smtClean="0"/>
              <a:t>2023/6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CDAF7-D72C-469C-A9C4-EE2B49156CC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504421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D121A3-E3E5-469B-98E6-DF38CE66B53F}" type="datetimeFigureOut">
              <a:rPr lang="zh-CN" altLang="en-US" smtClean="0"/>
              <a:t>2023/6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CDAF7-D72C-469C-A9C4-EE2B49156CC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026715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D121A3-E3E5-469B-98E6-DF38CE66B53F}" type="datetimeFigureOut">
              <a:rPr lang="zh-CN" altLang="en-US" smtClean="0"/>
              <a:t>2023/6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CDAF7-D72C-469C-A9C4-EE2B49156CC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604813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D121A3-E3E5-469B-98E6-DF38CE66B53F}" type="datetimeFigureOut">
              <a:rPr lang="zh-CN" altLang="en-US" smtClean="0"/>
              <a:t>2023/6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CDAF7-D72C-469C-A9C4-EE2B49156CC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951675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D121A3-E3E5-469B-98E6-DF38CE66B53F}" type="datetimeFigureOut">
              <a:rPr lang="zh-CN" altLang="en-US" smtClean="0"/>
              <a:t>2023/6/1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CDAF7-D72C-469C-A9C4-EE2B49156CC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178851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D121A3-E3E5-469B-98E6-DF38CE66B53F}" type="datetimeFigureOut">
              <a:rPr lang="zh-CN" altLang="en-US" smtClean="0"/>
              <a:t>2023/6/17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CDAF7-D72C-469C-A9C4-EE2B49156CC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465437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D121A3-E3E5-469B-98E6-DF38CE66B53F}" type="datetimeFigureOut">
              <a:rPr lang="zh-CN" altLang="en-US" smtClean="0"/>
              <a:t>2023/6/17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CDAF7-D72C-469C-A9C4-EE2B49156CC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400791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D121A3-E3E5-469B-98E6-DF38CE66B53F}" type="datetimeFigureOut">
              <a:rPr lang="zh-CN" altLang="en-US" smtClean="0"/>
              <a:t>2023/6/17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CDAF7-D72C-469C-A9C4-EE2B49156CC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301059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D121A3-E3E5-469B-98E6-DF38CE66B53F}" type="datetimeFigureOut">
              <a:rPr lang="zh-CN" altLang="en-US" smtClean="0"/>
              <a:t>2023/6/1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CDAF7-D72C-469C-A9C4-EE2B49156CC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475083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D121A3-E3E5-469B-98E6-DF38CE66B53F}" type="datetimeFigureOut">
              <a:rPr lang="zh-CN" altLang="en-US" smtClean="0"/>
              <a:t>2023/6/1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CDAF7-D72C-469C-A9C4-EE2B49156CC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667109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D121A3-E3E5-469B-98E6-DF38CE66B53F}" type="datetimeFigureOut">
              <a:rPr lang="zh-CN" altLang="en-US" smtClean="0"/>
              <a:t>2023/6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7CDAF7-D72C-469C-A9C4-EE2B49156CC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791907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6486ABF4-0CFB-1C64-AE20-3B8117404DF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2875" y="1739216"/>
            <a:ext cx="8858250" cy="2240494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AC4F5954-804D-0879-5841-A3594A09FD1A}"/>
              </a:ext>
            </a:extLst>
          </p:cNvPr>
          <p:cNvSpPr txBox="1"/>
          <p:nvPr/>
        </p:nvSpPr>
        <p:spPr>
          <a:xfrm>
            <a:off x="587375" y="4965154"/>
            <a:ext cx="7969250" cy="61709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2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Figure S1.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 (A) M. </a:t>
            </a:r>
            <a:r>
              <a:rPr lang="en-US" altLang="zh-CN" sz="1200" kern="100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ovipneumoniae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 colonies on SP-4 agar plate showing dew drop appearance. (B) M. </a:t>
            </a:r>
            <a:r>
              <a:rPr lang="en-US" altLang="zh-CN" sz="1200" kern="100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filiformis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 colonies on SP-4 agar plate showing fried egg appearance. (C) Microscopic morphology of M. </a:t>
            </a:r>
            <a:r>
              <a:rPr lang="en-US" altLang="zh-CN" sz="1200" kern="100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ovipneumoniae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.</a:t>
            </a:r>
            <a:endParaRPr lang="zh-CN" altLang="zh-CN" sz="11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1586354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7AC304E1-B495-FBA7-02DC-B29AC086F8A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843954"/>
            <a:ext cx="9144000" cy="3696891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ECD9D458-BEC0-FE38-8B29-AB524F87FEDD}"/>
              </a:ext>
            </a:extLst>
          </p:cNvPr>
          <p:cNvSpPr txBox="1"/>
          <p:nvPr/>
        </p:nvSpPr>
        <p:spPr>
          <a:xfrm>
            <a:off x="768350" y="5219154"/>
            <a:ext cx="7969250" cy="61709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2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Figure S2. 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Distribution of recombinant sequences over the </a:t>
            </a:r>
            <a:r>
              <a:rPr lang="en-US" altLang="zh-CN" sz="1200" i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Mycoplasma </a:t>
            </a:r>
            <a:r>
              <a:rPr lang="en-US" altLang="zh-CN" sz="1200" i="1" kern="100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ovipneumoniae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 core genome. Black segments below the recombinant regions indicate recombination hotspots.</a:t>
            </a:r>
            <a:endParaRPr lang="zh-CN" altLang="zh-CN" sz="11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5019911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图片 6">
            <a:extLst>
              <a:ext uri="{FF2B5EF4-FFF2-40B4-BE49-F238E27FC236}">
                <a16:creationId xmlns:a16="http://schemas.microsoft.com/office/drawing/2014/main" id="{CDC567BC-7CAD-CB98-1B60-6AE1A4171B2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05000" y="733490"/>
            <a:ext cx="5334000" cy="4002024"/>
          </a:xfrm>
          <a:prstGeom prst="rect">
            <a:avLst/>
          </a:prstGeo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6091E5C7-D4CF-8680-A430-CE9DA5711070}"/>
              </a:ext>
            </a:extLst>
          </p:cNvPr>
          <p:cNvSpPr txBox="1"/>
          <p:nvPr/>
        </p:nvSpPr>
        <p:spPr>
          <a:xfrm>
            <a:off x="2286000" y="5186364"/>
            <a:ext cx="4572000" cy="34009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2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Figure S3. 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Results of genetic structure analysis of strain population.</a:t>
            </a:r>
            <a:endParaRPr lang="zh-CN" altLang="zh-CN" sz="12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2501608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660AEF29-FE90-A4C2-2CE0-C862619D8C3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00300" y="622300"/>
            <a:ext cx="4660900" cy="4660900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FB1A187C-1512-9103-B012-584F8283A2BC}"/>
              </a:ext>
            </a:extLst>
          </p:cNvPr>
          <p:cNvSpPr txBox="1"/>
          <p:nvPr/>
        </p:nvSpPr>
        <p:spPr>
          <a:xfrm>
            <a:off x="1225550" y="5564616"/>
            <a:ext cx="7270750" cy="61709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2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Figure S4.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 New genes and unique genes. Graph representing new genes (solid line) and unique genes (dotted line) of the 23 </a:t>
            </a:r>
            <a:r>
              <a:rPr lang="en-US" altLang="zh-CN" sz="1200" i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Mycoplasma </a:t>
            </a:r>
            <a:r>
              <a:rPr lang="en-US" altLang="zh-CN" sz="1200" i="1" kern="100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ovipneumoniae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 genomes.</a:t>
            </a:r>
            <a:endParaRPr lang="zh-CN" altLang="zh-CN" sz="12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758796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6</TotalTime>
  <Words>112</Words>
  <Application>Microsoft Office PowerPoint</Application>
  <PresentationFormat>全屏显示(4:3)</PresentationFormat>
  <Paragraphs>4</Paragraphs>
  <Slides>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10" baseType="lpstr">
      <vt:lpstr>等线</vt:lpstr>
      <vt:lpstr>Arial</vt:lpstr>
      <vt:lpstr>Calibri</vt:lpstr>
      <vt:lpstr>Calibri Light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KG</dc:creator>
  <cp:lastModifiedBy>kui kang</cp:lastModifiedBy>
  <cp:revision>2</cp:revision>
  <dcterms:created xsi:type="dcterms:W3CDTF">2023-04-23T08:55:51Z</dcterms:created>
  <dcterms:modified xsi:type="dcterms:W3CDTF">2023-06-16T16:22:19Z</dcterms:modified>
</cp:coreProperties>
</file>